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105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C49E0-A622-428A-B226-CEFEF7B3E25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53137-9BE3-4016-88C5-5783977903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604322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C49E0-A622-428A-B226-CEFEF7B3E25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53137-9BE3-4016-88C5-5783977903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39721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C49E0-A622-428A-B226-CEFEF7B3E25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53137-9BE3-4016-88C5-5783977903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189848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C49E0-A622-428A-B226-CEFEF7B3E25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53137-9BE3-4016-88C5-5783977903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66622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C49E0-A622-428A-B226-CEFEF7B3E25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53137-9BE3-4016-88C5-5783977903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788433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C49E0-A622-428A-B226-CEFEF7B3E25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53137-9BE3-4016-88C5-5783977903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229905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C49E0-A622-428A-B226-CEFEF7B3E25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53137-9BE3-4016-88C5-5783977903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78639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C49E0-A622-428A-B226-CEFEF7B3E25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53137-9BE3-4016-88C5-5783977903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684960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C49E0-A622-428A-B226-CEFEF7B3E25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53137-9BE3-4016-88C5-5783977903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95094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C49E0-A622-428A-B226-CEFEF7B3E25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53137-9BE3-4016-88C5-5783977903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244635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C49E0-A622-428A-B226-CEFEF7B3E25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53137-9BE3-4016-88C5-5783977903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5363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1C49E0-A622-428A-B226-CEFEF7B3E25F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853137-9BE3-4016-88C5-57839779032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50020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595313" y="766223"/>
          <a:ext cx="6727490" cy="2140077"/>
        </p:xfrm>
        <a:graphic>
          <a:graphicData uri="http://schemas.openxmlformats.org/drawingml/2006/table">
            <a:tbl>
              <a:tblPr/>
              <a:tblGrid>
                <a:gridCol w="740613"/>
                <a:gridCol w="916624"/>
                <a:gridCol w="1321327"/>
                <a:gridCol w="740613"/>
                <a:gridCol w="438790"/>
                <a:gridCol w="438790"/>
                <a:gridCol w="1259971"/>
                <a:gridCol w="870762"/>
              </a:tblGrid>
              <a:tr h="190500">
                <a:tc rowSpan="2">
                  <a:txBody>
                    <a:bodyPr/>
                    <a:lstStyle/>
                    <a:p>
                      <a:pPr marL="0" marR="0" algn="ctr" fontAlgn="ctr">
                        <a:lnSpc>
                          <a:spcPts val="15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NILs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 fontAlgn="ctr">
                        <a:lnSpc>
                          <a:spcPts val="15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Recurrent </a:t>
                      </a: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Calibri" panose="020F0502020204030204"/>
                          <a:cs typeface="Times New Roman" panose="02020603050405020304"/>
                        </a:rPr>
                        <a:t>p</a:t>
                      </a: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arent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 fontAlgn="ctr">
                        <a:lnSpc>
                          <a:spcPts val="15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No. of </a:t>
                      </a: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Calibri" panose="020F0502020204030204"/>
                          <a:cs typeface="Times New Roman" panose="02020603050405020304"/>
                        </a:rPr>
                        <a:t>p</a:t>
                      </a: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olymorphic SNPs</a:t>
                      </a:r>
                      <a:r>
                        <a:rPr lang="en-US" sz="1100" kern="12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a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0" marR="0" algn="ctr" fontAlgn="ctr">
                        <a:lnSpc>
                          <a:spcPts val="15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No. of SNP alleles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ctr" fontAlgn="ctr">
                        <a:lnSpc>
                          <a:spcPts val="15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Percent recurrent parent genome recovery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 fontAlgn="ctr">
                        <a:lnSpc>
                          <a:spcPts val="15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Stigma length (mm)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9052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Recurrent parent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OL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Hetero SNPs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47650">
                <a:tc>
                  <a:txBody>
                    <a:bodyPr/>
                    <a:lstStyle/>
                    <a:p>
                      <a:pPr marL="0" marR="0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91A-18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IR58025B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536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407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29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7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92.21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2.18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marL="0" marR="0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91B-12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Calibri" panose="020F05020202040302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536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415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21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92.43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2.43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3680">
                <a:tc>
                  <a:txBody>
                    <a:bodyPr/>
                    <a:lstStyle/>
                    <a:p>
                      <a:pPr marL="0" marR="0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91B-42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>
                        <a:effectLst/>
                        <a:latin typeface="Calibri" panose="020F05020202040302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536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416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20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92.43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2.22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marL="0" marR="0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07A-35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IR68897B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549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377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72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35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88.90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2.61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marL="0" marR="0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07B-12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>
                        <a:effectLst/>
                        <a:latin typeface="Calibri" panose="020F05020202040302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549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373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66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7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90.35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2.08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marL="0" marR="0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W70B-12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>
                        <a:effectLst/>
                        <a:latin typeface="Calibri" panose="020F05020202040302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549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280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269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8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83.87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2.38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marL="0" marR="0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W70B-42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549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1282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267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8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83.89</a:t>
                      </a:r>
                      <a:endParaRPr lang="en-US" sz="110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ts val="1575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2.14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578977" y="2971800"/>
          <a:ext cx="6934200" cy="228600"/>
        </p:xfrm>
        <a:graphic>
          <a:graphicData uri="http://schemas.openxmlformats.org/drawingml/2006/table">
            <a:tbl>
              <a:tblPr/>
              <a:tblGrid>
                <a:gridCol w="6934200"/>
              </a:tblGrid>
              <a:tr h="228600"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a</a:t>
                      </a: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Times New Roman" panose="02020603050405020304"/>
                          <a:cs typeface="Times New Roman" panose="02020603050405020304"/>
                        </a:rPr>
                        <a:t> Total number of polymorphic SNPs between donor and recurrent parents</a:t>
                      </a:r>
                      <a:endParaRPr lang="en-US" sz="1100" dirty="0">
                        <a:effectLst/>
                        <a:latin typeface="Calibri" panose="020F0502020204030204"/>
                        <a:ea typeface="Calibri" panose="020F0502020204030204"/>
                        <a:cs typeface="Times New Roman" panose="020206030504050203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431810" y="168992"/>
            <a:ext cx="8520166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spAutoFit/>
          </a:bodyPr>
          <a:lstStyle/>
          <a:p>
            <a:pPr marL="447675" marR="0" lvl="0" indent="-447675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dditional file 3:  Table S3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ackground genotyping analysis of the improved maintainer and CMS lines using high resolution Infinium 7K SNP chip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77164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3</Words>
  <Application>Microsoft Office PowerPoint</Application>
  <PresentationFormat>On-screen Show (4:3)</PresentationFormat>
  <Paragraphs>6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jela Priency D.</dc:creator>
  <cp:lastModifiedBy>Anjela Priency D.</cp:lastModifiedBy>
  <cp:revision>1</cp:revision>
  <dcterms:created xsi:type="dcterms:W3CDTF">2021-09-02T09:29:22Z</dcterms:created>
  <dcterms:modified xsi:type="dcterms:W3CDTF">2021-09-02T09:29:36Z</dcterms:modified>
</cp:coreProperties>
</file>